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9" userDrawn="1">
          <p15:clr>
            <a:srgbClr val="A4A3A4"/>
          </p15:clr>
        </p15:guide>
        <p15:guide id="2" pos="3182" userDrawn="1">
          <p15:clr>
            <a:srgbClr val="A4A3A4"/>
          </p15:clr>
        </p15:guide>
        <p15:guide id="3" orient="horz" pos="6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620"/>
    <p:restoredTop sz="94620"/>
  </p:normalViewPr>
  <p:slideViewPr>
    <p:cSldViewPr snapToGrid="0" snapToObjects="1" showGuides="1">
      <p:cViewPr varScale="1">
        <p:scale>
          <a:sx n="110" d="100"/>
          <a:sy n="110" d="100"/>
        </p:scale>
        <p:origin x="496" y="168"/>
      </p:cViewPr>
      <p:guideLst>
        <p:guide orient="horz" pos="799"/>
        <p:guide pos="3182"/>
        <p:guide orient="horz" pos="6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5C1B5B-DF66-3442-9AAD-DCE72149AE94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E17E54-5032-BE41-BEA8-F276CBD94FF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6250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E17E54-5032-BE41-BEA8-F276CBD94FF4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4581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296EFB-A662-6B40-8F67-4AFA494AE9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653A54D-ECB4-D84D-AC64-C9A3588BAD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D808B10-3DC5-8E45-BA88-F88F4F89A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087315E-DAFB-3944-AFC0-2ECCC03A5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682D18-740E-8041-AC5C-6CC8DCBE3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6250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577242-004E-4841-9BFC-93A8EDCDB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EA809BE-5966-734F-AE6A-FD83D54DB5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9616316-4243-1A4E-85AB-8FCEC6843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39265D3-0364-3748-8DC8-26D0366BF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39491A7-EFE2-7747-A445-5C8EFF91FA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739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AF9303C-5C03-0D42-BD65-63613A4FE4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D723BC9-C52E-9141-8EEE-428608F755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3B9DBBE-382A-8646-AB83-E42F29F34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2ADD2F2-C967-AA44-A57F-5122B1C61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92D71D9-5CD0-3249-BE58-C19D98337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0764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7988B9-E5AC-B64C-86FB-17C86AE81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793FAF1-A25E-4241-B1D6-67AC0A0FB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5B04D6A-9BEA-684F-8126-39EE5C585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5B2F836-CFE7-3843-A845-447222000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B6C0BAE-30F6-B741-818B-9CBEE38E09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7303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F1B73F6-5D5A-044F-B6AB-2A6D5EC53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59E8FD0-279A-0248-9D24-A2912501B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A698001-14FA-6B41-A52F-D3EB18F38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D20594F-9F9D-F640-BCAA-0D634AFDD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D36FD33-D855-0B48-9A02-7997F19EF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6509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CC7011-D92F-864B-AAD5-89249CE497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B7305D7-BB47-024C-AC60-19073263AE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0CE3109-540B-1F4C-B522-00E90AA2D1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F876E25-5DEB-6C40-B6D2-59782D800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9085EB0-40BB-314E-8303-62C939848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F2C2DFB-1102-AF42-822B-E07A48288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6269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6078C6-43F5-5448-8058-22C53B59D2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C00CD65-4367-FC4B-9A75-8B3AADE91A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E2BFD27-BEB7-DD43-A5E2-F34B83D836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651B03D-3F57-DC48-BD6B-021AD31D13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C353B31-7F2E-8443-863B-4A92F37186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04EDF48-1429-6F42-9EF9-FFE32B209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182AEFB-6C0E-1B46-A48E-98635FF81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B6E03F7-6996-5E43-9109-EFC858431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0470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CEAD7D-8410-1445-BE27-CD09013079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6B3153B-368B-2741-A942-4E495DFEA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306A1C1-906F-0F45-A4F5-7182980BF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B8BFBC6-D549-F649-B46A-D4222399F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7543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061C92D-B667-E84E-8628-860FED71D6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CB634B2-C642-774D-882D-317CE2E47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8F26BC1-37A9-4F4F-9C49-A3B8D1C54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6283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CEC771-7FAE-8B4D-BC19-5000DBF39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A0A0A6A-0075-5845-9EFB-9D79A20873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C14BD9E-E048-B94E-B909-5E73D927E5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859A774-3A0C-BA4C-BFCD-3F3421BCE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44C353-17DF-C641-9C2A-26106D42D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84430FD-07E6-244B-A300-508F650A5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7348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4B1FFB-703C-FF44-8ED9-498E07C49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FDD22E8-A8C6-F145-A997-FDC6C08C25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985C510-EC0C-CE4E-9177-B7008D228C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DC5BEC5-0297-8649-B546-4D73DCF23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A1FE389-E39A-BE4E-BC89-AC50F2A26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3AEF52F-4916-BB49-8AD1-94C69C9BA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1764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0BEF08C-4ABE-A148-B929-9ED8451B5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BD714A5-77E4-3A4B-B432-A9A3D68750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C11E421-14D1-9444-BDF1-FC8E6301B5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43529-E2B1-694A-98FF-A266EE46A486}" type="datetimeFigureOut">
              <a:rPr lang="de-DE" smtClean="0"/>
              <a:t>07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83C6E29-E8BD-E541-979C-BBEB18CEFE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B3B9014-F83F-5046-A7E5-602E68D3CD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E0C2D-738D-5B4E-A38E-3C70CC0E1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5506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F1433E97-9809-B649-8D43-4E9503605711}"/>
              </a:ext>
            </a:extLst>
          </p:cNvPr>
          <p:cNvSpPr txBox="1"/>
          <p:nvPr/>
        </p:nvSpPr>
        <p:spPr>
          <a:xfrm>
            <a:off x="198164" y="168486"/>
            <a:ext cx="6826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. Figure 1</a:t>
            </a:r>
          </a:p>
        </p:txBody>
      </p:sp>
      <p:grpSp>
        <p:nvGrpSpPr>
          <p:cNvPr id="26" name="Gruppieren 25">
            <a:extLst>
              <a:ext uri="{FF2B5EF4-FFF2-40B4-BE49-F238E27FC236}">
                <a16:creationId xmlns:a16="http://schemas.microsoft.com/office/drawing/2014/main" id="{D3DCE71D-2B1B-856E-1B70-161AA63A997F}"/>
              </a:ext>
            </a:extLst>
          </p:cNvPr>
          <p:cNvGrpSpPr/>
          <p:nvPr/>
        </p:nvGrpSpPr>
        <p:grpSpPr>
          <a:xfrm>
            <a:off x="4427402" y="1587288"/>
            <a:ext cx="1921397" cy="567867"/>
            <a:chOff x="10576299" y="1169693"/>
            <a:chExt cx="1921397" cy="567867"/>
          </a:xfrm>
        </p:grpSpPr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0E3C1B76-48DA-19ED-585C-EDC2658841EC}"/>
                </a:ext>
              </a:extLst>
            </p:cNvPr>
            <p:cNvSpPr txBox="1"/>
            <p:nvPr/>
          </p:nvSpPr>
          <p:spPr>
            <a:xfrm>
              <a:off x="10576299" y="1169693"/>
              <a:ext cx="54401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__ </a:t>
              </a:r>
            </a:p>
            <a:p>
              <a:r>
                <a:rPr lang="de-DE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__</a:t>
              </a:r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091F9499-DA0D-CEBF-EEA6-A5C0489F41E0}"/>
                </a:ext>
              </a:extLst>
            </p:cNvPr>
            <p:cNvSpPr txBox="1"/>
            <p:nvPr/>
          </p:nvSpPr>
          <p:spPr>
            <a:xfrm>
              <a:off x="10965980" y="1284875"/>
              <a:ext cx="15317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arcopeni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4D36B4F9-AA5A-C560-BD09-F0B7A15230E6}"/>
                </a:ext>
              </a:extLst>
            </p:cNvPr>
            <p:cNvSpPr txBox="1"/>
            <p:nvPr/>
          </p:nvSpPr>
          <p:spPr>
            <a:xfrm>
              <a:off x="10965980" y="1506728"/>
              <a:ext cx="153171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arcopeni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Textfeld 36">
            <a:extLst>
              <a:ext uri="{FF2B5EF4-FFF2-40B4-BE49-F238E27FC236}">
                <a16:creationId xmlns:a16="http://schemas.microsoft.com/office/drawing/2014/main" id="{31DA22D4-28B5-4D74-1EBE-D3FE59145E5A}"/>
              </a:ext>
            </a:extLst>
          </p:cNvPr>
          <p:cNvSpPr txBox="1"/>
          <p:nvPr/>
        </p:nvSpPr>
        <p:spPr>
          <a:xfrm>
            <a:off x="146489" y="948942"/>
            <a:ext cx="568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C4EEDA30-E6AA-A79F-123D-C19999D7156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24843" y="1491893"/>
            <a:ext cx="4058382" cy="2880000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E1C79AB1-7B57-37A2-90A7-EB6955615E05}"/>
              </a:ext>
            </a:extLst>
          </p:cNvPr>
          <p:cNvSpPr txBox="1"/>
          <p:nvPr/>
        </p:nvSpPr>
        <p:spPr>
          <a:xfrm>
            <a:off x="1526981" y="4336312"/>
            <a:ext cx="2347733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 after transplantation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519619AE-7301-3917-53E5-14B2ECE287B7}"/>
              </a:ext>
            </a:extLst>
          </p:cNvPr>
          <p:cNvSpPr txBox="1"/>
          <p:nvPr/>
        </p:nvSpPr>
        <p:spPr>
          <a:xfrm>
            <a:off x="3670701" y="3877763"/>
            <a:ext cx="7736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 = 0.141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7A5ED29C-DE01-868B-7027-4C49738A762A}"/>
              </a:ext>
            </a:extLst>
          </p:cNvPr>
          <p:cNvSpPr txBox="1"/>
          <p:nvPr/>
        </p:nvSpPr>
        <p:spPr>
          <a:xfrm rot="16200000">
            <a:off x="-439426" y="2768659"/>
            <a:ext cx="174777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patient survival</a:t>
            </a:r>
          </a:p>
        </p:txBody>
      </p:sp>
    </p:spTree>
    <p:extLst>
      <p:ext uri="{BB962C8B-B14F-4D97-AF65-F5344CB8AC3E}">
        <p14:creationId xmlns:p14="http://schemas.microsoft.com/office/powerpoint/2010/main" val="1618899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Breitbild</PresentationFormat>
  <Paragraphs>10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uliane Liese</dc:creator>
  <cp:lastModifiedBy>Juliane Liese</cp:lastModifiedBy>
  <cp:revision>95</cp:revision>
  <cp:lastPrinted>2022-01-17T19:31:36Z</cp:lastPrinted>
  <dcterms:created xsi:type="dcterms:W3CDTF">2021-06-23T19:41:16Z</dcterms:created>
  <dcterms:modified xsi:type="dcterms:W3CDTF">2023-01-07T00:19:57Z</dcterms:modified>
</cp:coreProperties>
</file>